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3F2F5-79DE-4E77-8D53-9C7E8076A6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F690D-A579-45D6-80A1-A1900DE64E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E90F82-157F-4848-ABDF-7BE434C3F1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902D6-E9C1-4F58-9710-6CF3D42264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3B07F-CD81-4F19-8D32-94F900BFDE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0578E-1233-4D61-A1FB-568D81A9CC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DDEBBC-8794-4189-A449-B62BCF93EF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972B4-D6D8-45F9-9916-E2730E257F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77386-32DF-48AF-AB7F-14218B346A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04BD0-2E3F-465D-BCAF-9AFDCDE868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6F0A9-8498-439C-ABB1-8BCBD1B23D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2CFFF-C984-4ADF-92D5-24A67FEA28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35CAAF-BC39-4B2F-9FDA-5DD3172C8BE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152280" y="192240"/>
            <a:ext cx="6782040" cy="41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1. Positive rate and distribution of fluorescent antibody responses of sera by surveyed are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52280" y="685800"/>
          <a:ext cx="8831520" cy="4432320"/>
        </p:xfrm>
        <a:graphic>
          <a:graphicData uri="http://schemas.openxmlformats.org/drawingml/2006/table">
            <a:tbl>
              <a:tblPr/>
              <a:tblGrid>
                <a:gridCol w="782640"/>
                <a:gridCol w="619200"/>
                <a:gridCol w="619200"/>
                <a:gridCol w="619200"/>
                <a:gridCol w="618840"/>
                <a:gridCol w="619200"/>
                <a:gridCol w="619200"/>
                <a:gridCol w="619200"/>
                <a:gridCol w="522360"/>
                <a:gridCol w="685800"/>
                <a:gridCol w="685800"/>
                <a:gridCol w="582480"/>
                <a:gridCol w="619200"/>
                <a:gridCol w="619200"/>
              </a:tblGrid>
              <a:tr h="52632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re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Sera Tes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Positive Ser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7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IFAT serum dilution endpoi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si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b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API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c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749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&lt;1: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≥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: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: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:1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:2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:5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≥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:10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6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Gimp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3.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.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6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aju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.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6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Yeonche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.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.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6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Cheorw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7.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6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Goseon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252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5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4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7.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3" name="Text Box 123"/>
          <p:cNvSpPr/>
          <p:nvPr/>
        </p:nvSpPr>
        <p:spPr>
          <a:xfrm>
            <a:off x="304920" y="6673680"/>
            <a:ext cx="39607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24"/>
          <p:cNvSpPr/>
          <p:nvPr/>
        </p:nvSpPr>
        <p:spPr>
          <a:xfrm>
            <a:off x="914400" y="5181480"/>
            <a:ext cx="7848720" cy="163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Note.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IFAT; Indirect fluorescent antibody test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API; Annual antibody positive index determined by IF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PI; Annual parasite index of 2005 and 20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* Significant between AAPI and positive rate of IFAT was analyzed by Two-way ANOVA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1010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#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positive rate of IFAT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4583, 2006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0913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&amp;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AAPI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7436, 2006;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0003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8T01:57:13Z</dcterms:created>
  <dc:creator>Lee</dc:creator>
  <dc:description/>
  <dc:language>en-US</dc:language>
  <cp:lastModifiedBy>Marcel Hommel</cp:lastModifiedBy>
  <dcterms:modified xsi:type="dcterms:W3CDTF">2012-07-22T10:27:19Z</dcterms:modified>
  <cp:revision>3</cp:revision>
  <dc:subject/>
  <dc:title>Slide 1</dc:title>
</cp:coreProperties>
</file>